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2" d="100"/>
          <a:sy n="102" d="100"/>
        </p:scale>
        <p:origin x="144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伊藤　龍一" userId="d4b21ca6-d7a4-440c-b344-fcf63bb452b7" providerId="ADAL" clId="{D442895A-EEE7-43C2-9138-90EF0CA0C07F}"/>
    <pc:docChg chg="undo custSel addSld modSld">
      <pc:chgData name="伊藤　龍一" userId="d4b21ca6-d7a4-440c-b344-fcf63bb452b7" providerId="ADAL" clId="{D442895A-EEE7-43C2-9138-90EF0CA0C07F}" dt="2022-11-18T08:29:07.948" v="514" actId="113"/>
      <pc:docMkLst>
        <pc:docMk/>
      </pc:docMkLst>
      <pc:sldChg chg="addSp delSp modSp new mod">
        <pc:chgData name="伊藤　龍一" userId="d4b21ca6-d7a4-440c-b344-fcf63bb452b7" providerId="ADAL" clId="{D442895A-EEE7-43C2-9138-90EF0CA0C07F}" dt="2022-11-18T08:29:07.948" v="514" actId="113"/>
        <pc:sldMkLst>
          <pc:docMk/>
          <pc:sldMk cId="1319169152" sldId="256"/>
        </pc:sldMkLst>
        <pc:spChg chg="del mod">
          <ac:chgData name="伊藤　龍一" userId="d4b21ca6-d7a4-440c-b344-fcf63bb452b7" providerId="ADAL" clId="{D442895A-EEE7-43C2-9138-90EF0CA0C07F}" dt="2022-11-15T13:29:11.208" v="24" actId="478"/>
          <ac:spMkLst>
            <pc:docMk/>
            <pc:sldMk cId="1319169152" sldId="256"/>
            <ac:spMk id="2" creationId="{CE9B0B7B-9DFA-33F5-DB73-4C76AFC6DEC8}"/>
          </ac:spMkLst>
        </pc:spChg>
        <pc:spChg chg="add del mod">
          <ac:chgData name="伊藤　龍一" userId="d4b21ca6-d7a4-440c-b344-fcf63bb452b7" providerId="ADAL" clId="{D442895A-EEE7-43C2-9138-90EF0CA0C07F}" dt="2022-11-15T13:29:13.519" v="26" actId="478"/>
          <ac:spMkLst>
            <pc:docMk/>
            <pc:sldMk cId="1319169152" sldId="256"/>
            <ac:spMk id="5" creationId="{2FF0DEC9-3A57-EEAC-A5B7-2E25FC17B1CC}"/>
          </ac:spMkLst>
        </pc:spChg>
        <pc:spChg chg="add mod">
          <ac:chgData name="伊藤　龍一" userId="d4b21ca6-d7a4-440c-b344-fcf63bb452b7" providerId="ADAL" clId="{D442895A-EEE7-43C2-9138-90EF0CA0C07F}" dt="2022-11-18T07:51:52.345" v="513" actId="20577"/>
          <ac:spMkLst>
            <pc:docMk/>
            <pc:sldMk cId="1319169152" sldId="256"/>
            <ac:spMk id="6" creationId="{DE664EAC-B501-5EF1-76D8-28E41501BB7A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9" creationId="{467B8503-F2FD-035F-FB6B-D22F5E1E2F3A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10" creationId="{B910D8AB-44D2-AF71-31F3-7F08267E2B25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11" creationId="{C74EBB18-87B5-6B30-5FF5-8B0BCE9AEEBC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12" creationId="{52F08222-F820-830E-03DC-BBBDE2A04B9B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13" creationId="{A7ACF926-E10F-A8DE-169E-A9A2A8CB161E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14" creationId="{0D41DB58-99BB-4E1A-A3DB-07DAB44D69BE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15" creationId="{22F65A05-5361-E332-86D2-FB1E0EFA71D3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16" creationId="{8643F874-129D-F959-3165-AC1E1A7F25BF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17" creationId="{28782445-53DF-55F3-F113-ECAC78E7EF9E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18" creationId="{79BFA4AB-CE6F-071B-C473-4C410759F13A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19" creationId="{7E47FDF3-FE74-7C2A-12FE-EF0BB2150A21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20" creationId="{C8CA77AC-949B-3639-EB0F-A3914C13A053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21" creationId="{8B421F9B-FEB9-A1DC-965F-BDFDF1244DED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22" creationId="{25CDA8EE-AA6C-A7BC-95B4-6A88B093F482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23" creationId="{2127C13D-50B4-16AF-3ED0-C5F558F02D42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24" creationId="{73CBCD50-1D26-E83C-5BCE-D7DFCD714033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25" creationId="{E04782A4-46EB-BA83-DA06-E82BC68FEFCB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26" creationId="{7C327D22-D38F-9CA2-950A-2CBFFD796330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27" creationId="{D7BFDA4D-3799-90F6-894D-8EDB709504A2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28" creationId="{25EB0B2D-CAF9-9E3B-D08F-FAB6A1E82BA7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29" creationId="{08C435E9-E399-F160-F066-354FD019FA66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30" creationId="{4C86038E-8D71-6C98-9BE3-5E5A03FA319C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31" creationId="{BAC71741-15EE-B58B-55E8-1A07846A320D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32" creationId="{BD68796A-363A-EEE1-1EFC-1A29E6C2A329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33" creationId="{8A9049DF-02D7-DB51-75D2-43B13285473B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34" creationId="{523A3FCF-75D2-B9A2-71DA-6D07F3547387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35" creationId="{8E28AD35-79E9-B472-6A94-1DD269F56957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36" creationId="{3BAFE0B1-1922-BC7D-6397-18990CC9659C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37" creationId="{52567D51-8FE8-9173-5F76-9592D63D6C91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38" creationId="{99B16BF6-3075-B741-CFBF-10E89DABAE26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39" creationId="{102B9E32-6315-547D-6E66-512C9F7AD2B2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40" creationId="{20075207-3C88-925B-8DEF-03973CD55063}"/>
          </ac:spMkLst>
        </pc:spChg>
        <pc:spChg chg="mod">
          <ac:chgData name="伊藤　龍一" userId="d4b21ca6-d7a4-440c-b344-fcf63bb452b7" providerId="ADAL" clId="{D442895A-EEE7-43C2-9138-90EF0CA0C07F}" dt="2022-11-15T13:29:56.245" v="95" actId="338"/>
          <ac:spMkLst>
            <pc:docMk/>
            <pc:sldMk cId="1319169152" sldId="256"/>
            <ac:spMk id="41" creationId="{8480C37E-94C2-CB7E-AEAC-74E4DA49CF2A}"/>
          </ac:spMkLst>
        </pc:spChg>
        <pc:spChg chg="del mod">
          <ac:chgData name="伊藤　龍一" userId="d4b21ca6-d7a4-440c-b344-fcf63bb452b7" providerId="ADAL" clId="{D442895A-EEE7-43C2-9138-90EF0CA0C07F}" dt="2022-11-15T13:52:08.727" v="102" actId="478"/>
          <ac:spMkLst>
            <pc:docMk/>
            <pc:sldMk cId="1319169152" sldId="256"/>
            <ac:spMk id="43" creationId="{47205262-9856-AF89-EDD4-BFEFC83CCFF0}"/>
          </ac:spMkLst>
        </pc:spChg>
        <pc:spChg chg="mod ord topLvl">
          <ac:chgData name="伊藤　龍一" userId="d4b21ca6-d7a4-440c-b344-fcf63bb452b7" providerId="ADAL" clId="{D442895A-EEE7-43C2-9138-90EF0CA0C07F}" dt="2022-11-15T14:05:52.353" v="365" actId="207"/>
          <ac:spMkLst>
            <pc:docMk/>
            <pc:sldMk cId="1319169152" sldId="256"/>
            <ac:spMk id="44" creationId="{BD6399D3-9967-F55E-BF65-CB6D6F1F7C7F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45" creationId="{4309CFF6-48C0-F141-14D5-AC3F41AE3B8D}"/>
          </ac:spMkLst>
        </pc:spChg>
        <pc:spChg chg="mod ord topLvl">
          <ac:chgData name="伊藤　龍一" userId="d4b21ca6-d7a4-440c-b344-fcf63bb452b7" providerId="ADAL" clId="{D442895A-EEE7-43C2-9138-90EF0CA0C07F}" dt="2022-11-15T14:05:19.157" v="361" actId="166"/>
          <ac:spMkLst>
            <pc:docMk/>
            <pc:sldMk cId="1319169152" sldId="256"/>
            <ac:spMk id="46" creationId="{F8C45ABB-BF6E-D443-2EB2-8F8AE06F4EDC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47" creationId="{A73FB6F6-3E9C-877E-31E5-8EC9BBD5552F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48" creationId="{965BC988-7950-9847-C2B4-8EE45F166591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49" creationId="{17707767-7748-381E-ACF2-F61310BFC18E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50" creationId="{E03F2C46-FFCC-30E4-615F-7A9804C711BF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51" creationId="{61E64B5A-FCEA-A914-0235-A996B1CC371E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52" creationId="{3EEE339A-089D-57A6-1BC6-C450EB0FBA19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53" creationId="{8C1FE56B-93E0-C23C-8038-8A20DA0EB5E3}"/>
          </ac:spMkLst>
        </pc:spChg>
        <pc:spChg chg="mod topLvl">
          <ac:chgData name="伊藤　龍一" userId="d4b21ca6-d7a4-440c-b344-fcf63bb452b7" providerId="ADAL" clId="{D442895A-EEE7-43C2-9138-90EF0CA0C07F}" dt="2022-11-15T14:05:24.330" v="363" actId="1037"/>
          <ac:spMkLst>
            <pc:docMk/>
            <pc:sldMk cId="1319169152" sldId="256"/>
            <ac:spMk id="54" creationId="{4CCF6C2F-67B4-EB27-F557-353BA054E883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55" creationId="{85656B0F-B03C-D3DA-E78E-1C5C2D2FC348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56" creationId="{7A07D0C5-80E5-03B0-B9AB-913CE48A75EB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57" creationId="{5A9A646F-0572-A44C-B8EA-76E8A30B2DC6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58" creationId="{100B0914-6F68-42B4-2DE4-B8496546A934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59" creationId="{C126FEAD-C1FB-1B8B-AC2B-54D471A2318A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60" creationId="{33E93389-F0A9-F37E-7CF5-510107F754A1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61" creationId="{D3F6E2F1-05D0-C376-7A59-9E103C2631CF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62" creationId="{B67A14C6-F8D1-DC19-0461-EB9B4B575CA4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63" creationId="{9F4997FB-23B5-8859-9261-729746998CAF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64" creationId="{4C64B38B-EE7E-C88C-1B5F-93E8ED986530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65" creationId="{9CD0D793-116E-12D5-2197-6D987AD4CCBF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66" creationId="{84E78577-F8A6-3EEF-F94C-19AE0E53FE12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67" creationId="{E5918580-61F1-DE5F-C498-827D86291237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68" creationId="{0C8794D6-C7DB-D57D-39F0-F91A5FCC7FAD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69" creationId="{23445AD8-489D-A5A7-CC35-58CF41B037EE}"/>
          </ac:spMkLst>
        </pc:spChg>
        <pc:spChg chg="mod topLvl">
          <ac:chgData name="伊藤　龍一" userId="d4b21ca6-d7a4-440c-b344-fcf63bb452b7" providerId="ADAL" clId="{D442895A-EEE7-43C2-9138-90EF0CA0C07F}" dt="2022-11-15T14:05:46.164" v="364" actId="167"/>
          <ac:spMkLst>
            <pc:docMk/>
            <pc:sldMk cId="1319169152" sldId="256"/>
            <ac:spMk id="70" creationId="{5D5E73DA-B833-6528-EC82-0C6540FCCF81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71" creationId="{68955845-A8BE-AD6A-15D0-5EDE0CB07DBD}"/>
          </ac:spMkLst>
        </pc:spChg>
        <pc:spChg chg="mod topLvl">
          <ac:chgData name="伊藤　龍一" userId="d4b21ca6-d7a4-440c-b344-fcf63bb452b7" providerId="ADAL" clId="{D442895A-EEE7-43C2-9138-90EF0CA0C07F}" dt="2022-11-15T14:05:46.164" v="364" actId="167"/>
          <ac:spMkLst>
            <pc:docMk/>
            <pc:sldMk cId="1319169152" sldId="256"/>
            <ac:spMk id="72" creationId="{49FA0E60-30CA-1442-9EAA-DCB0D08C44A1}"/>
          </ac:spMkLst>
        </pc:spChg>
        <pc:spChg chg="mod topLvl">
          <ac:chgData name="伊藤　龍一" userId="d4b21ca6-d7a4-440c-b344-fcf63bb452b7" providerId="ADAL" clId="{D442895A-EEE7-43C2-9138-90EF0CA0C07F}" dt="2022-11-15T14:05:46.164" v="364" actId="167"/>
          <ac:spMkLst>
            <pc:docMk/>
            <pc:sldMk cId="1319169152" sldId="256"/>
            <ac:spMk id="73" creationId="{0E9DC7DF-BE91-731B-1DB0-BD0BCBC1EB26}"/>
          </ac:spMkLst>
        </pc:spChg>
        <pc:spChg chg="mod topLvl">
          <ac:chgData name="伊藤　龍一" userId="d4b21ca6-d7a4-440c-b344-fcf63bb452b7" providerId="ADAL" clId="{D442895A-EEE7-43C2-9138-90EF0CA0C07F}" dt="2022-11-15T14:02:23.715" v="289" actId="113"/>
          <ac:spMkLst>
            <pc:docMk/>
            <pc:sldMk cId="1319169152" sldId="256"/>
            <ac:spMk id="74" creationId="{70061EA3-00AD-7164-4E13-15918E6BBE2A}"/>
          </ac:spMkLst>
        </pc:spChg>
        <pc:spChg chg="mod topLvl">
          <ac:chgData name="伊藤　龍一" userId="d4b21ca6-d7a4-440c-b344-fcf63bb452b7" providerId="ADAL" clId="{D442895A-EEE7-43C2-9138-90EF0CA0C07F}" dt="2022-11-15T14:05:46.164" v="364" actId="167"/>
          <ac:spMkLst>
            <pc:docMk/>
            <pc:sldMk cId="1319169152" sldId="256"/>
            <ac:spMk id="75" creationId="{AD6AA8AD-F568-E7F5-5858-734229546E5F}"/>
          </ac:spMkLst>
        </pc:spChg>
        <pc:spChg chg="add mod">
          <ac:chgData name="伊藤　龍一" userId="d4b21ca6-d7a4-440c-b344-fcf63bb452b7" providerId="ADAL" clId="{D442895A-EEE7-43C2-9138-90EF0CA0C07F}" dt="2022-11-15T14:06:04.501" v="366" actId="1076"/>
          <ac:spMkLst>
            <pc:docMk/>
            <pc:sldMk cId="1319169152" sldId="256"/>
            <ac:spMk id="76" creationId="{97244D9A-508E-A8F3-6EAA-92D40788A6AC}"/>
          </ac:spMkLst>
        </pc:spChg>
        <pc:spChg chg="add mod">
          <ac:chgData name="伊藤　龍一" userId="d4b21ca6-d7a4-440c-b344-fcf63bb452b7" providerId="ADAL" clId="{D442895A-EEE7-43C2-9138-90EF0CA0C07F}" dt="2022-11-18T08:29:07.948" v="514" actId="113"/>
          <ac:spMkLst>
            <pc:docMk/>
            <pc:sldMk cId="1319169152" sldId="256"/>
            <ac:spMk id="77" creationId="{0945335E-C18E-6B72-3E38-4916448A51C9}"/>
          </ac:spMkLst>
        </pc:spChg>
        <pc:grpChg chg="mod">
          <ac:chgData name="伊藤　龍一" userId="d4b21ca6-d7a4-440c-b344-fcf63bb452b7" providerId="ADAL" clId="{D442895A-EEE7-43C2-9138-90EF0CA0C07F}" dt="2022-11-15T13:30:22.904" v="101" actId="338"/>
          <ac:grpSpMkLst>
            <pc:docMk/>
            <pc:sldMk cId="1319169152" sldId="256"/>
            <ac:grpSpMk id="1" creationId="{00000000-0000-0000-0000-000000000000}"/>
          </ac:grpSpMkLst>
        </pc:grpChg>
        <pc:grpChg chg="mod">
          <ac:chgData name="伊藤　龍一" userId="d4b21ca6-d7a4-440c-b344-fcf63bb452b7" providerId="ADAL" clId="{D442895A-EEE7-43C2-9138-90EF0CA0C07F}" dt="2022-11-15T13:29:56.245" v="95" actId="338"/>
          <ac:grpSpMkLst>
            <pc:docMk/>
            <pc:sldMk cId="1319169152" sldId="256"/>
            <ac:grpSpMk id="8" creationId="{F5B507C7-66C8-FA30-6CE5-8DB606CF29E0}"/>
          </ac:grpSpMkLst>
        </pc:grpChg>
        <pc:grpChg chg="del mod">
          <ac:chgData name="伊藤　龍一" userId="d4b21ca6-d7a4-440c-b344-fcf63bb452b7" providerId="ADAL" clId="{D442895A-EEE7-43C2-9138-90EF0CA0C07F}" dt="2022-11-15T13:52:56.072" v="114" actId="165"/>
          <ac:grpSpMkLst>
            <pc:docMk/>
            <pc:sldMk cId="1319169152" sldId="256"/>
            <ac:grpSpMk id="42" creationId="{94CE2093-0094-6B5A-8365-E84D85EF10CA}"/>
          </ac:grpSpMkLst>
        </pc:grpChg>
        <pc:picChg chg="add del mod">
          <ac:chgData name="伊藤　龍一" userId="d4b21ca6-d7a4-440c-b344-fcf63bb452b7" providerId="ADAL" clId="{D442895A-EEE7-43C2-9138-90EF0CA0C07F}" dt="2022-11-15T13:30:22.904" v="101" actId="338"/>
          <ac:picMkLst>
            <pc:docMk/>
            <pc:sldMk cId="1319169152" sldId="256"/>
            <ac:picMk id="4" creationId="{B1AC2039-D6DD-0432-0DBC-19AF219AEF8A}"/>
          </ac:picMkLst>
        </pc:picChg>
        <pc:picChg chg="add del mod">
          <ac:chgData name="伊藤　龍一" userId="d4b21ca6-d7a4-440c-b344-fcf63bb452b7" providerId="ADAL" clId="{D442895A-EEE7-43C2-9138-90EF0CA0C07F}" dt="2022-11-14T03:44:15.347" v="3"/>
          <ac:picMkLst>
            <pc:docMk/>
            <pc:sldMk cId="1319169152" sldId="256"/>
            <ac:picMk id="5" creationId="{AFF3B893-715E-381F-A390-B90F473F5AD2}"/>
          </ac:picMkLst>
        </pc:picChg>
        <pc:picChg chg="add del mod">
          <ac:chgData name="伊藤　龍一" userId="d4b21ca6-d7a4-440c-b344-fcf63bb452b7" providerId="ADAL" clId="{D442895A-EEE7-43C2-9138-90EF0CA0C07F}" dt="2022-11-15T14:09:03.475" v="510" actId="478"/>
          <ac:picMkLst>
            <pc:docMk/>
            <pc:sldMk cId="1319169152" sldId="256"/>
            <ac:picMk id="7" creationId="{1357DECA-2888-590E-8C5F-0D841AD00A61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7B17917-48D0-55E1-CF5B-70BB57575F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921E2BC-9DA3-D179-5E34-B14AB10D49C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A50132C-7126-850D-398E-5244F9DE64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E0775-296C-4570-8D10-45B583D96DD4}" type="datetimeFigureOut">
              <a:rPr kumimoji="1" lang="ja-JP" altLang="en-US" smtClean="0"/>
              <a:t>2022/1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733BAE6-A4F5-78C6-2BE1-93F9E2D3F9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5E0762A-CEFF-7F13-75A5-7AFCB11EC5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32A26-4748-4267-895F-259F4870C5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18428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3510AC-8442-4037-79A4-4A9735F28E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1C8974F-7C66-221D-80AE-C0DB24FCDE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C566208-8AA7-8B63-B49D-1DDB62CB17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E0775-296C-4570-8D10-45B583D96DD4}" type="datetimeFigureOut">
              <a:rPr kumimoji="1" lang="ja-JP" altLang="en-US" smtClean="0"/>
              <a:t>2022/1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A41C009-14E9-12E1-9CF9-D8A30154FF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E59DA79-7F41-0463-0382-3E49D87F7E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32A26-4748-4267-895F-259F4870C5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55091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A83495E-3346-3F5E-A824-CED9BDA722D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80680A6-C8FC-C153-3379-8F912F087D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A2AB6A0-2AF1-DE2B-4B01-5B969F2E45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E0775-296C-4570-8D10-45B583D96DD4}" type="datetimeFigureOut">
              <a:rPr kumimoji="1" lang="ja-JP" altLang="en-US" smtClean="0"/>
              <a:t>2022/1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507906E-D658-DD37-A6A6-CBE6DFB85A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4599CB4-9966-E745-5ECB-14C28DA25B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32A26-4748-4267-895F-259F4870C5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2113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57B5A31-11AD-0E32-4D21-608038F06C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8D9E3D4-7335-9115-4128-BF71B899F5B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04ACB0F-095E-5EA1-AADB-022540809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E0775-296C-4570-8D10-45B583D96DD4}" type="datetimeFigureOut">
              <a:rPr kumimoji="1" lang="ja-JP" altLang="en-US" smtClean="0"/>
              <a:t>2022/1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2910CCE-CBD6-EA30-6FAB-C0F6315CC1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45738B7-6C36-2AFB-A6AD-75FE389CF1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32A26-4748-4267-895F-259F4870C5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98648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031286D-F145-DED8-471D-B7039C138F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F3DABEC-E07D-B27E-47D7-89CE26165D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F89B017-015F-A965-F30B-A2DF1B099A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E0775-296C-4570-8D10-45B583D96DD4}" type="datetimeFigureOut">
              <a:rPr kumimoji="1" lang="ja-JP" altLang="en-US" smtClean="0"/>
              <a:t>2022/1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373CD5E-E536-1D96-E459-46625B57E1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864DBFE-E366-13ED-5571-70B3DE49BF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32A26-4748-4267-895F-259F4870C5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46552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7337DBD-E479-1F86-88DB-0F186E5E8C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4CF7C4E-A775-7F2F-B6B0-42A0F6B674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1196EA8-3E4B-EA8C-76D1-A65CB9F609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342AE8E-4E52-7D75-5019-05140F8FAC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E0775-296C-4570-8D10-45B583D96DD4}" type="datetimeFigureOut">
              <a:rPr kumimoji="1" lang="ja-JP" altLang="en-US" smtClean="0"/>
              <a:t>2022/11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25B680C-5A4F-1879-C374-5BB37AF91C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3D98043-288C-8503-0B47-02044B14E9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32A26-4748-4267-895F-259F4870C5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8626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FECC364-E257-FB25-C52A-990C21A811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BFFD9CF-77BD-ADA6-606B-C8057A73C6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63B896B-0BF0-4A93-BD28-D902F08818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4C737F2-025A-13D1-BD85-77D60C7F09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ACF393F-086D-7335-90BA-BDBDE400E8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237BE06-4984-1E15-6A49-D21C333AEF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E0775-296C-4570-8D10-45B583D96DD4}" type="datetimeFigureOut">
              <a:rPr kumimoji="1" lang="ja-JP" altLang="en-US" smtClean="0"/>
              <a:t>2022/11/1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55569EC-7D4B-1BA5-99E9-8570566522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8158188-048B-E8F4-0797-9BADED0AF3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32A26-4748-4267-895F-259F4870C5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55995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22BF41-35CC-51E8-D2EA-9A07748945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57B1FD0-046A-68F3-430C-F688F91777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E0775-296C-4570-8D10-45B583D96DD4}" type="datetimeFigureOut">
              <a:rPr kumimoji="1" lang="ja-JP" altLang="en-US" smtClean="0"/>
              <a:t>2022/11/1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4A02B47-07CC-6633-69FE-9CEF2EAFF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EEA4A0B-E2CA-BF66-E706-46302017E8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32A26-4748-4267-895F-259F4870C5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97500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29ADD08-E522-5421-09D3-3DC0B914B5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E0775-296C-4570-8D10-45B583D96DD4}" type="datetimeFigureOut">
              <a:rPr kumimoji="1" lang="ja-JP" altLang="en-US" smtClean="0"/>
              <a:t>2022/11/1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D3FB31A-3AA2-9CE6-66B5-CDD3DBEB49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714D784-940C-C42E-DDA9-F5A798B33F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32A26-4748-4267-895F-259F4870C5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29400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2DE0D5-890F-693E-CBB1-D3D7C0983D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79BAEA0-0DF2-BCE1-B05B-81789AFFB76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66063FF-069B-F75A-B561-BE9EC2E989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D967321-61A3-6DAC-7B0C-0C7879E25A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E0775-296C-4570-8D10-45B583D96DD4}" type="datetimeFigureOut">
              <a:rPr kumimoji="1" lang="ja-JP" altLang="en-US" smtClean="0"/>
              <a:t>2022/11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F49AB18-C1F2-E7D4-8827-CDED7898D6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9792C23-16E6-B3EC-F55B-26C75DB458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32A26-4748-4267-895F-259F4870C5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19086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EB1DD03-2F8F-12EB-5B07-9F2EA279E8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09D2C47-7AD6-BFAB-A790-112D0544C9A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BA548DA-88D0-6F76-509C-96EB0755C7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C46B719-5D89-9608-1AC8-B081A4C680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E0775-296C-4570-8D10-45B583D96DD4}" type="datetimeFigureOut">
              <a:rPr kumimoji="1" lang="ja-JP" altLang="en-US" smtClean="0"/>
              <a:t>2022/11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31E94FC-513D-FA55-2F01-1FAB9497A6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D8BB3F7-F473-54EF-FB8C-E764E20312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32A26-4748-4267-895F-259F4870C5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38872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BDDA26C-0851-D6D8-9EFF-242AEC126F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E1210A4-CD83-2A56-F5E3-74D2712A15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AFBF6E3-FD85-79D4-99BF-CA83E60490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8E0775-296C-4570-8D10-45B583D96DD4}" type="datetimeFigureOut">
              <a:rPr kumimoji="1" lang="ja-JP" altLang="en-US" smtClean="0"/>
              <a:t>2022/11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E4DFA97-EA58-D92F-16C6-DD55701502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1086750-D53C-D9FA-D4A1-6AA742A1E9D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232A26-4748-4267-895F-259F4870C5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90507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Line 66">
            <a:extLst>
              <a:ext uri="{FF2B5EF4-FFF2-40B4-BE49-F238E27FC236}">
                <a16:creationId xmlns:a16="http://schemas.microsoft.com/office/drawing/2014/main" id="{5D5E73DA-B833-6528-EC82-0C6540FCCF81}"/>
              </a:ext>
            </a:extLst>
          </p:cNvPr>
          <p:cNvSpPr>
            <a:spLocks noChangeShapeType="1"/>
          </p:cNvSpPr>
          <p:nvPr/>
        </p:nvSpPr>
        <p:spPr bwMode="auto">
          <a:xfrm>
            <a:off x="5303842" y="2351088"/>
            <a:ext cx="0" cy="1947864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4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Freeform 68">
            <a:extLst>
              <a:ext uri="{FF2B5EF4-FFF2-40B4-BE49-F238E27FC236}">
                <a16:creationId xmlns:a16="http://schemas.microsoft.com/office/drawing/2014/main" id="{49FA0E60-30CA-1442-9EAA-DCB0D08C44A1}"/>
              </a:ext>
            </a:extLst>
          </p:cNvPr>
          <p:cNvSpPr>
            <a:spLocks/>
          </p:cNvSpPr>
          <p:nvPr/>
        </p:nvSpPr>
        <p:spPr bwMode="auto">
          <a:xfrm>
            <a:off x="5248279" y="4298952"/>
            <a:ext cx="117475" cy="0"/>
          </a:xfrm>
          <a:custGeom>
            <a:avLst/>
            <a:gdLst>
              <a:gd name="T0" fmla="*/ 0 w 19"/>
              <a:gd name="T1" fmla="*/ 9 w 19"/>
              <a:gd name="T2" fmla="*/ 19 w 19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9">
                <a:moveTo>
                  <a:pt x="0" y="0"/>
                </a:moveTo>
                <a:lnTo>
                  <a:pt x="9" y="0"/>
                </a:lnTo>
                <a:lnTo>
                  <a:pt x="19" y="0"/>
                </a:lnTo>
              </a:path>
            </a:pathLst>
          </a:cu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4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Line 69">
            <a:extLst>
              <a:ext uri="{FF2B5EF4-FFF2-40B4-BE49-F238E27FC236}">
                <a16:creationId xmlns:a16="http://schemas.microsoft.com/office/drawing/2014/main" id="{0E9DC7DF-BE91-731B-1DB0-BD0BCBC1EB26}"/>
              </a:ext>
            </a:extLst>
          </p:cNvPr>
          <p:cNvSpPr>
            <a:spLocks noChangeShapeType="1"/>
          </p:cNvSpPr>
          <p:nvPr/>
        </p:nvSpPr>
        <p:spPr bwMode="auto">
          <a:xfrm>
            <a:off x="7023106" y="2173288"/>
            <a:ext cx="0" cy="2230440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4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Freeform 71">
            <a:extLst>
              <a:ext uri="{FF2B5EF4-FFF2-40B4-BE49-F238E27FC236}">
                <a16:creationId xmlns:a16="http://schemas.microsoft.com/office/drawing/2014/main" id="{AD6AA8AD-F568-E7F5-5858-734229546E5F}"/>
              </a:ext>
            </a:extLst>
          </p:cNvPr>
          <p:cNvSpPr>
            <a:spLocks/>
          </p:cNvSpPr>
          <p:nvPr/>
        </p:nvSpPr>
        <p:spPr bwMode="auto">
          <a:xfrm>
            <a:off x="6962781" y="4403728"/>
            <a:ext cx="122238" cy="0"/>
          </a:xfrm>
          <a:custGeom>
            <a:avLst/>
            <a:gdLst>
              <a:gd name="T0" fmla="*/ 0 w 20"/>
              <a:gd name="T1" fmla="*/ 10 w 20"/>
              <a:gd name="T2" fmla="*/ 20 w 20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0">
                <a:moveTo>
                  <a:pt x="0" y="0"/>
                </a:moveTo>
                <a:lnTo>
                  <a:pt x="10" y="0"/>
                </a:lnTo>
                <a:lnTo>
                  <a:pt x="20" y="0"/>
                </a:lnTo>
              </a:path>
            </a:pathLst>
          </a:cu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4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E664EAC-B501-5EF1-76D8-28E41501BB7A}"/>
              </a:ext>
            </a:extLst>
          </p:cNvPr>
          <p:cNvSpPr txBox="1"/>
          <p:nvPr/>
        </p:nvSpPr>
        <p:spPr>
          <a:xfrm>
            <a:off x="2177393" y="95145"/>
            <a:ext cx="7837214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24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ＭＳ Ｐゴシック" charset="-128"/>
                <a:cs typeface="Times New Roman" panose="02020603050405020304" pitchFamily="18" charset="0"/>
              </a:rPr>
              <a:t>Supplement Figure S2. The size of metastatic lymph node according to PDH-E1</a:t>
            </a:r>
            <a:r>
              <a:rPr lang="ja-JP" altLang="ja-JP" sz="1800" b="1" dirty="0">
                <a:effectLst/>
                <a:ea typeface="Times New Roman" panose="02020603050405020304" pitchFamily="18" charset="0"/>
              </a:rPr>
              <a:t>α</a:t>
            </a:r>
            <a:r>
              <a:rPr kumimoji="1" lang="en-US" altLang="ja-JP" sz="24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ＭＳ Ｐゴシック" charset="-128"/>
                <a:cs typeface="Times New Roman" panose="02020603050405020304" pitchFamily="18" charset="0"/>
              </a:rPr>
              <a:t> expression</a:t>
            </a:r>
          </a:p>
          <a:p>
            <a:pPr algn="ctr"/>
            <a:r>
              <a:rPr kumimoji="1" lang="en-US" altLang="ja-JP" sz="24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ＭＳ Ｐゴシック" charset="-128"/>
                <a:cs typeface="Times New Roman" panose="02020603050405020304" pitchFamily="18" charset="0"/>
              </a:rPr>
              <a:t> Ito R. </a:t>
            </a:r>
            <a:r>
              <a:rPr kumimoji="1" lang="en-US" altLang="ja-JP" sz="2400" b="1" i="1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ＭＳ Ｐゴシック" charset="-128"/>
                <a:cs typeface="Times New Roman" panose="02020603050405020304" pitchFamily="18" charset="0"/>
              </a:rPr>
              <a:t>et al.</a:t>
            </a:r>
            <a:endParaRPr lang="ja-JP" altLang="en-US" sz="1200" i="1" dirty="0"/>
          </a:p>
        </p:txBody>
      </p:sp>
      <p:sp>
        <p:nvSpPr>
          <p:cNvPr id="44" name="Rectangle 40">
            <a:extLst>
              <a:ext uri="{FF2B5EF4-FFF2-40B4-BE49-F238E27FC236}">
                <a16:creationId xmlns:a16="http://schemas.microsoft.com/office/drawing/2014/main" id="{BD6399D3-9967-F55E-BF65-CB6D6F1F7C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91054" y="3322639"/>
            <a:ext cx="1431926" cy="1393826"/>
          </a:xfrm>
          <a:prstGeom prst="rect">
            <a:avLst/>
          </a:prstGeom>
          <a:solidFill>
            <a:schemeClr val="bg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4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Rectangle 41">
            <a:extLst>
              <a:ext uri="{FF2B5EF4-FFF2-40B4-BE49-F238E27FC236}">
                <a16:creationId xmlns:a16="http://schemas.microsoft.com/office/drawing/2014/main" id="{4309CFF6-48C0-F141-14D5-AC3F41AE3B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91054" y="3322639"/>
            <a:ext cx="1431926" cy="1393826"/>
          </a:xfrm>
          <a:prstGeom prst="rect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4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Rectangle 42">
            <a:extLst>
              <a:ext uri="{FF2B5EF4-FFF2-40B4-BE49-F238E27FC236}">
                <a16:creationId xmlns:a16="http://schemas.microsoft.com/office/drawing/2014/main" id="{F8C45ABB-BF6E-D443-2EB2-8F8AE06F4E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0318" y="3284539"/>
            <a:ext cx="1431926" cy="1431926"/>
          </a:xfrm>
          <a:prstGeom prst="rect">
            <a:avLst/>
          </a:prstGeom>
          <a:solidFill>
            <a:srgbClr val="BEBEBE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4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Rectangle 43">
            <a:extLst>
              <a:ext uri="{FF2B5EF4-FFF2-40B4-BE49-F238E27FC236}">
                <a16:creationId xmlns:a16="http://schemas.microsoft.com/office/drawing/2014/main" id="{A73FB6F6-3E9C-877E-31E5-8EC9BBD555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0318" y="3284539"/>
            <a:ext cx="1431926" cy="1431926"/>
          </a:xfrm>
          <a:prstGeom prst="rect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4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Line 44">
            <a:extLst>
              <a:ext uri="{FF2B5EF4-FFF2-40B4-BE49-F238E27FC236}">
                <a16:creationId xmlns:a16="http://schemas.microsoft.com/office/drawing/2014/main" id="{965BC988-7950-9847-C2B4-8EE45F166591}"/>
              </a:ext>
            </a:extLst>
          </p:cNvPr>
          <p:cNvSpPr>
            <a:spLocks noChangeShapeType="1"/>
          </p:cNvSpPr>
          <p:nvPr/>
        </p:nvSpPr>
        <p:spPr bwMode="auto">
          <a:xfrm>
            <a:off x="5303842" y="4716465"/>
            <a:ext cx="1719264" cy="0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4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Line 45">
            <a:extLst>
              <a:ext uri="{FF2B5EF4-FFF2-40B4-BE49-F238E27FC236}">
                <a16:creationId xmlns:a16="http://schemas.microsoft.com/office/drawing/2014/main" id="{17707767-7748-381E-ACF2-F61310BFC18E}"/>
              </a:ext>
            </a:extLst>
          </p:cNvPr>
          <p:cNvSpPr>
            <a:spLocks noChangeShapeType="1"/>
          </p:cNvSpPr>
          <p:nvPr/>
        </p:nvSpPr>
        <p:spPr bwMode="auto">
          <a:xfrm>
            <a:off x="5303842" y="4716465"/>
            <a:ext cx="0" cy="55563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4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Line 46">
            <a:extLst>
              <a:ext uri="{FF2B5EF4-FFF2-40B4-BE49-F238E27FC236}">
                <a16:creationId xmlns:a16="http://schemas.microsoft.com/office/drawing/2014/main" id="{E03F2C46-FFCC-30E4-615F-7A9804C711BF}"/>
              </a:ext>
            </a:extLst>
          </p:cNvPr>
          <p:cNvSpPr>
            <a:spLocks noChangeShapeType="1"/>
          </p:cNvSpPr>
          <p:nvPr/>
        </p:nvSpPr>
        <p:spPr bwMode="auto">
          <a:xfrm>
            <a:off x="7023106" y="4716465"/>
            <a:ext cx="0" cy="55563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4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Rectangle 47">
            <a:extLst>
              <a:ext uri="{FF2B5EF4-FFF2-40B4-BE49-F238E27FC236}">
                <a16:creationId xmlns:a16="http://schemas.microsoft.com/office/drawing/2014/main" id="{61E64B5A-FCEA-A914-0235-A996B1CC37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69903" y="4845053"/>
            <a:ext cx="76944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ositive</a:t>
            </a:r>
            <a:endParaRPr kumimoji="0" lang="ja-JP" altLang="ja-JP" sz="4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Rectangle 48">
            <a:extLst>
              <a:ext uri="{FF2B5EF4-FFF2-40B4-BE49-F238E27FC236}">
                <a16:creationId xmlns:a16="http://schemas.microsoft.com/office/drawing/2014/main" id="{3EEE339A-089D-57A6-1BC6-C450EB0FBA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81230" y="4845053"/>
            <a:ext cx="85921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egative</a:t>
            </a:r>
            <a:endParaRPr kumimoji="0" lang="ja-JP" altLang="ja-JP" sz="4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Rectangle 49">
            <a:extLst>
              <a:ext uri="{FF2B5EF4-FFF2-40B4-BE49-F238E27FC236}">
                <a16:creationId xmlns:a16="http://schemas.microsoft.com/office/drawing/2014/main" id="{8C1FE56B-93E0-C23C-8038-8A20DA0EB5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65146" y="5157126"/>
            <a:ext cx="211179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DH</a:t>
            </a:r>
            <a:r>
              <a:rPr kumimoji="0" lang="en-US" altLang="ja-JP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E1</a:t>
            </a:r>
            <a:r>
              <a:rPr lang="ja-JP" altLang="ja-JP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kumimoji="0" lang="en-US" altLang="ja-JP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 expression</a:t>
            </a:r>
            <a:endParaRPr kumimoji="0" lang="ja-JP" altLang="ja-JP" sz="4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Rectangle 50">
            <a:extLst>
              <a:ext uri="{FF2B5EF4-FFF2-40B4-BE49-F238E27FC236}">
                <a16:creationId xmlns:a16="http://schemas.microsoft.com/office/drawing/2014/main" id="{4CCF6C2F-67B4-EB27-F557-353BA054E883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752353" y="3097788"/>
            <a:ext cx="226554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ajor diameter (mm)</a:t>
            </a:r>
            <a:endParaRPr kumimoji="0" lang="ja-JP" altLang="ja-JP" sz="4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Line 51">
            <a:extLst>
              <a:ext uri="{FF2B5EF4-FFF2-40B4-BE49-F238E27FC236}">
                <a16:creationId xmlns:a16="http://schemas.microsoft.com/office/drawing/2014/main" id="{85656B0F-B03C-D3DA-E78E-1C5C2D2FC34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462466" y="1822450"/>
            <a:ext cx="0" cy="2894015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4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Line 52">
            <a:extLst>
              <a:ext uri="{FF2B5EF4-FFF2-40B4-BE49-F238E27FC236}">
                <a16:creationId xmlns:a16="http://schemas.microsoft.com/office/drawing/2014/main" id="{7A07D0C5-80E5-03B0-B9AB-913CE48A75E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406904" y="4716465"/>
            <a:ext cx="55563" cy="0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4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Line 53">
            <a:extLst>
              <a:ext uri="{FF2B5EF4-FFF2-40B4-BE49-F238E27FC236}">
                <a16:creationId xmlns:a16="http://schemas.microsoft.com/office/drawing/2014/main" id="{5A9A646F-0572-A44C-B8EA-76E8A30B2DC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406904" y="4230690"/>
            <a:ext cx="55563" cy="0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4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Line 54">
            <a:extLst>
              <a:ext uri="{FF2B5EF4-FFF2-40B4-BE49-F238E27FC236}">
                <a16:creationId xmlns:a16="http://schemas.microsoft.com/office/drawing/2014/main" id="{100B0914-6F68-42B4-2DE4-B8496546A93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406904" y="3751264"/>
            <a:ext cx="55563" cy="0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4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Line 55">
            <a:extLst>
              <a:ext uri="{FF2B5EF4-FFF2-40B4-BE49-F238E27FC236}">
                <a16:creationId xmlns:a16="http://schemas.microsoft.com/office/drawing/2014/main" id="{C126FEAD-C1FB-1B8B-AC2B-54D471A2318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406904" y="3267076"/>
            <a:ext cx="55563" cy="0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4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Line 56">
            <a:extLst>
              <a:ext uri="{FF2B5EF4-FFF2-40B4-BE49-F238E27FC236}">
                <a16:creationId xmlns:a16="http://schemas.microsoft.com/office/drawing/2014/main" id="{33E93389-F0A9-F37E-7CF5-510107F754A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406904" y="2787651"/>
            <a:ext cx="55563" cy="0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4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Line 57">
            <a:extLst>
              <a:ext uri="{FF2B5EF4-FFF2-40B4-BE49-F238E27FC236}">
                <a16:creationId xmlns:a16="http://schemas.microsoft.com/office/drawing/2014/main" id="{D3F6E2F1-05D0-C376-7A59-9E103C2631C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406904" y="2301876"/>
            <a:ext cx="55563" cy="0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4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Line 58">
            <a:extLst>
              <a:ext uri="{FF2B5EF4-FFF2-40B4-BE49-F238E27FC236}">
                <a16:creationId xmlns:a16="http://schemas.microsoft.com/office/drawing/2014/main" id="{B67A14C6-F8D1-DC19-0461-EB9B4B575CA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406904" y="1822450"/>
            <a:ext cx="55563" cy="0"/>
          </a:xfrm>
          <a:prstGeom prst="line">
            <a:avLst/>
          </a:pr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4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Rectangle 59">
            <a:extLst>
              <a:ext uri="{FF2B5EF4-FFF2-40B4-BE49-F238E27FC236}">
                <a16:creationId xmlns:a16="http://schemas.microsoft.com/office/drawing/2014/main" id="{9F4997FB-23B5-8859-9261-729746998C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5194" y="4568348"/>
            <a:ext cx="1154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4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Rectangle 60">
            <a:extLst>
              <a:ext uri="{FF2B5EF4-FFF2-40B4-BE49-F238E27FC236}">
                <a16:creationId xmlns:a16="http://schemas.microsoft.com/office/drawing/2014/main" id="{4C64B38B-EE7E-C88C-1B5F-93E8ED9865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5194" y="4088922"/>
            <a:ext cx="1154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0" lang="ja-JP" altLang="ja-JP" sz="4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Rectangle 61">
            <a:extLst>
              <a:ext uri="{FF2B5EF4-FFF2-40B4-BE49-F238E27FC236}">
                <a16:creationId xmlns:a16="http://schemas.microsoft.com/office/drawing/2014/main" id="{9CD0D793-116E-12D5-2197-6D987AD4CC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5194" y="3603147"/>
            <a:ext cx="1154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0" lang="ja-JP" altLang="ja-JP" sz="4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Rectangle 62">
            <a:extLst>
              <a:ext uri="{FF2B5EF4-FFF2-40B4-BE49-F238E27FC236}">
                <a16:creationId xmlns:a16="http://schemas.microsoft.com/office/drawing/2014/main" id="{84E78577-F8A6-3EEF-F94C-19AE0E53FE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5194" y="3125309"/>
            <a:ext cx="1154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0" lang="ja-JP" altLang="ja-JP" sz="4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Rectangle 63">
            <a:extLst>
              <a:ext uri="{FF2B5EF4-FFF2-40B4-BE49-F238E27FC236}">
                <a16:creationId xmlns:a16="http://schemas.microsoft.com/office/drawing/2014/main" id="{E5918580-61F1-DE5F-C498-827D862912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5194" y="2639533"/>
            <a:ext cx="1154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0" lang="ja-JP" altLang="ja-JP" sz="4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Rectangle 64">
            <a:extLst>
              <a:ext uri="{FF2B5EF4-FFF2-40B4-BE49-F238E27FC236}">
                <a16:creationId xmlns:a16="http://schemas.microsoft.com/office/drawing/2014/main" id="{0C8794D6-C7DB-D57D-39F0-F91A5FCC7F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79632" y="2160108"/>
            <a:ext cx="23083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0" lang="ja-JP" altLang="ja-JP" sz="4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Rectangle 65">
            <a:extLst>
              <a:ext uri="{FF2B5EF4-FFF2-40B4-BE49-F238E27FC236}">
                <a16:creationId xmlns:a16="http://schemas.microsoft.com/office/drawing/2014/main" id="{23445AD8-489D-A5A7-CC35-58CF41B037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79632" y="1675920"/>
            <a:ext cx="23083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endParaRPr kumimoji="0" lang="ja-JP" altLang="ja-JP" sz="4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Freeform 67">
            <a:extLst>
              <a:ext uri="{FF2B5EF4-FFF2-40B4-BE49-F238E27FC236}">
                <a16:creationId xmlns:a16="http://schemas.microsoft.com/office/drawing/2014/main" id="{68955845-A8BE-AD6A-15D0-5EDE0CB07DBD}"/>
              </a:ext>
            </a:extLst>
          </p:cNvPr>
          <p:cNvSpPr>
            <a:spLocks/>
          </p:cNvSpPr>
          <p:nvPr/>
        </p:nvSpPr>
        <p:spPr bwMode="auto">
          <a:xfrm>
            <a:off x="5248279" y="2351088"/>
            <a:ext cx="117475" cy="0"/>
          </a:xfrm>
          <a:custGeom>
            <a:avLst/>
            <a:gdLst>
              <a:gd name="T0" fmla="*/ 19 w 19"/>
              <a:gd name="T1" fmla="*/ 9 w 19"/>
              <a:gd name="T2" fmla="*/ 0 w 19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9">
                <a:moveTo>
                  <a:pt x="19" y="0"/>
                </a:moveTo>
                <a:lnTo>
                  <a:pt x="9" y="0"/>
                </a:lnTo>
                <a:lnTo>
                  <a:pt x="0" y="0"/>
                </a:lnTo>
              </a:path>
            </a:pathLst>
          </a:cu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4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Freeform 70">
            <a:extLst>
              <a:ext uri="{FF2B5EF4-FFF2-40B4-BE49-F238E27FC236}">
                <a16:creationId xmlns:a16="http://schemas.microsoft.com/office/drawing/2014/main" id="{70061EA3-00AD-7164-4E13-15918E6BBE2A}"/>
              </a:ext>
            </a:extLst>
          </p:cNvPr>
          <p:cNvSpPr>
            <a:spLocks/>
          </p:cNvSpPr>
          <p:nvPr/>
        </p:nvSpPr>
        <p:spPr bwMode="auto">
          <a:xfrm>
            <a:off x="6962781" y="2173288"/>
            <a:ext cx="122238" cy="0"/>
          </a:xfrm>
          <a:custGeom>
            <a:avLst/>
            <a:gdLst>
              <a:gd name="T0" fmla="*/ 20 w 20"/>
              <a:gd name="T1" fmla="*/ 10 w 20"/>
              <a:gd name="T2" fmla="*/ 0 w 20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20">
                <a:moveTo>
                  <a:pt x="20" y="0"/>
                </a:moveTo>
                <a:lnTo>
                  <a:pt x="10" y="0"/>
                </a:lnTo>
                <a:lnTo>
                  <a:pt x="0" y="0"/>
                </a:lnTo>
              </a:path>
            </a:pathLst>
          </a:custGeom>
          <a:noFill/>
          <a:ln w="2857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48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97244D9A-508E-A8F3-6EAA-92D40788A6AC}"/>
              </a:ext>
            </a:extLst>
          </p:cNvPr>
          <p:cNvSpPr txBox="1"/>
          <p:nvPr/>
        </p:nvSpPr>
        <p:spPr>
          <a:xfrm>
            <a:off x="5593402" y="1583587"/>
            <a:ext cx="9492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865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0945335E-C18E-6B72-3E38-4916448A51C9}"/>
              </a:ext>
            </a:extLst>
          </p:cNvPr>
          <p:cNvSpPr txBox="1"/>
          <p:nvPr/>
        </p:nvSpPr>
        <p:spPr>
          <a:xfrm>
            <a:off x="2281218" y="6086185"/>
            <a:ext cx="857798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legend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Major diameter of metastatic lymph node according to the expression of PDH-</a:t>
            </a:r>
            <a:r>
              <a:rPr kumimoji="0" lang="en-US" altLang="ja-JP" sz="14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1</a:t>
            </a:r>
            <a:r>
              <a:rPr lang="ja-JP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primary lesion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r>
              <a:rPr kumimoji="0" lang="ja-JP" altLang="ja-JP" sz="14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DH</a:t>
            </a:r>
            <a:r>
              <a:rPr kumimoji="0" lang="en-US" altLang="ja-JP" sz="14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E1</a:t>
            </a:r>
            <a:r>
              <a:rPr lang="ja-JP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400" dirty="0">
                <a:solidFill>
                  <a:srgbClr val="2E2E2E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yruvate dehydrogenase </a:t>
            </a:r>
            <a:r>
              <a:rPr kumimoji="0" lang="en-US" altLang="ja-JP" sz="14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1</a:t>
            </a:r>
            <a:r>
              <a:rPr lang="ja-JP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91691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0</TotalTime>
  <Words>72</Words>
  <Application>Microsoft Office PowerPoint</Application>
  <PresentationFormat>ワイド画面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伊藤　龍一</dc:creator>
  <cp:lastModifiedBy>伊藤　龍一</cp:lastModifiedBy>
  <cp:revision>1</cp:revision>
  <dcterms:created xsi:type="dcterms:W3CDTF">2022-11-14T03:43:45Z</dcterms:created>
  <dcterms:modified xsi:type="dcterms:W3CDTF">2022-11-18T08:29:10Z</dcterms:modified>
</cp:coreProperties>
</file>